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48" r:id="rId2"/>
  </p:sldIdLst>
  <p:sldSz cx="6858000" cy="1371600"/>
  <p:notesSz cx="6669088" cy="9775825"/>
  <p:defaultTextStyle>
    <a:defPPr>
      <a:defRPr lang="de-DE"/>
    </a:defPPr>
    <a:lvl1pPr marL="0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71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3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TKrueger" initials="TK" lastIdx="3" clrIdx="0"/>
  <p:cmAuthor id="1" name="Office" initials="O" lastIdx="1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6F664"/>
    <a:srgbClr val="FACE60"/>
    <a:srgbClr val="065A06"/>
    <a:srgbClr val="37441C"/>
    <a:srgbClr val="ADA36F"/>
    <a:srgbClr val="FF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00" autoAdjust="0"/>
    <p:restoredTop sz="98757" autoAdjust="0"/>
  </p:normalViewPr>
  <p:slideViewPr>
    <p:cSldViewPr>
      <p:cViewPr>
        <p:scale>
          <a:sx n="75" d="100"/>
          <a:sy n="75" d="100"/>
        </p:scale>
        <p:origin x="1732" y="1116"/>
      </p:cViewPr>
      <p:guideLst>
        <p:guide orient="horz" pos="432"/>
        <p:guide pos="2160"/>
      </p:guideLst>
    </p:cSldViewPr>
  </p:slideViewPr>
  <p:notesTextViewPr>
    <p:cViewPr>
      <p:scale>
        <a:sx n="33" d="100"/>
        <a:sy n="33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9CF3C3B8-13C0-45C6-9FFF-BCFBEA449F5A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9D8228-2921-4AB0-8D46-F38DF75D06B4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778250" y="0"/>
            <a:ext cx="2889250" cy="4905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BF47BF-6011-4EE6-A456-E4C5ECC88D20}" type="datetimeFigureOut">
              <a:rPr lang="en-US" smtClean="0"/>
              <a:t>02/0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BC20D87-F40E-47F4-ABF9-4ED4F9BD995B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841192-45A2-4783-A9D2-D9EC8A13F279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778250" y="9285288"/>
            <a:ext cx="2889250" cy="49053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434FD3-F380-421D-90B4-A8E7D6ECC1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688755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7245" y="0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/>
          <a:lstStyle>
            <a:lvl1pPr algn="r">
              <a:defRPr sz="1100"/>
            </a:lvl1pPr>
          </a:lstStyle>
          <a:p>
            <a:fld id="{AC1B7B2B-A260-417A-BF54-29F76BDEF745}" type="datetimeFigureOut">
              <a:rPr lang="de-DE" smtClean="0"/>
              <a:pPr/>
              <a:t>05.02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-5829300" y="733425"/>
            <a:ext cx="18327688" cy="36655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4320" tIns="42160" rIns="84320" bIns="4216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7454" y="4644136"/>
            <a:ext cx="5334181" cy="4398813"/>
          </a:xfrm>
          <a:prstGeom prst="rect">
            <a:avLst/>
          </a:prstGeom>
        </p:spPr>
        <p:txBody>
          <a:bodyPr vert="horz" lIns="84320" tIns="42160" rIns="84320" bIns="4216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l">
              <a:defRPr sz="11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7245" y="9285182"/>
            <a:ext cx="2890483" cy="489100"/>
          </a:xfrm>
          <a:prstGeom prst="rect">
            <a:avLst/>
          </a:prstGeom>
        </p:spPr>
        <p:txBody>
          <a:bodyPr vert="horz" lIns="84320" tIns="42160" rIns="84320" bIns="42160" rtlCol="0" anchor="b"/>
          <a:lstStyle>
            <a:lvl1pPr algn="r">
              <a:defRPr sz="1100"/>
            </a:lvl1pPr>
          </a:lstStyle>
          <a:p>
            <a:fld id="{0C4681C7-5AE4-4C4B-9445-68AE67E38C79}" type="slidenum">
              <a:rPr lang="de-DE" smtClean="0"/>
              <a:pPr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0574514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1pPr>
    <a:lvl2pPr marL="43616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2pPr>
    <a:lvl3pPr marL="872339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3pPr>
    <a:lvl4pPr marL="1308508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4pPr>
    <a:lvl5pPr marL="1744677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5pPr>
    <a:lvl6pPr marL="2180846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6pPr>
    <a:lvl7pPr marL="261701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7pPr>
    <a:lvl8pPr marL="3053185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8pPr>
    <a:lvl9pPr marL="3489354" algn="l" defTabSz="872339" rtl="0" eaLnBrk="1" latinLnBrk="0" hangingPunct="1">
      <a:defRPr sz="114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1" y="320910"/>
            <a:ext cx="617184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1" y="736378"/>
            <a:ext cx="617184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320910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320910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505320" y="736378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42720" y="736378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1" y="320910"/>
            <a:ext cx="6171840" cy="79544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42721" y="320910"/>
            <a:ext cx="6171840" cy="79544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pic>
        <p:nvPicPr>
          <p:cNvPr id="34" name="Grafik 33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377735"/>
            <a:ext cx="6171840" cy="681796"/>
          </a:xfrm>
          <a:prstGeom prst="rect">
            <a:avLst/>
          </a:prstGeom>
          <a:ln>
            <a:noFill/>
          </a:ln>
        </p:spPr>
      </p:pic>
      <p:pic>
        <p:nvPicPr>
          <p:cNvPr id="35" name="Grafik 34"/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42721" y="377735"/>
            <a:ext cx="6171840" cy="681796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1" y="320910"/>
            <a:ext cx="6171840" cy="795495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1" y="320910"/>
            <a:ext cx="6171840" cy="79544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320910"/>
            <a:ext cx="3011760" cy="79544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320910"/>
            <a:ext cx="3011760" cy="79544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1" y="54682"/>
            <a:ext cx="6171840" cy="106172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320910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42720" y="736378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505320" y="320910"/>
            <a:ext cx="3011760" cy="79544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320910"/>
            <a:ext cx="3011760" cy="795445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320910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736378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904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/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320910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320910"/>
            <a:ext cx="301176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1" y="736378"/>
            <a:ext cx="6171840" cy="379379"/>
          </a:xfrm>
          <a:prstGeom prst="rect">
            <a:avLst/>
          </a:prstGeom>
        </p:spPr>
        <p:txBody>
          <a:bodyPr lIns="0" tIns="0" rIns="0" bIns="0"/>
          <a:lstStyle/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1" y="54682"/>
            <a:ext cx="6171840" cy="228993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r>
              <a:rPr lang="en-US" sz="3588">
                <a:latin typeface="Arial"/>
              </a:rPr>
              <a:t>Click to edit the title text format</a:t>
            </a:r>
            <a:endParaRPr/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1" y="320910"/>
            <a:ext cx="6171840" cy="795445"/>
          </a:xfrm>
          <a:prstGeom prst="rect">
            <a:avLst/>
          </a:prstGeom>
        </p:spPr>
        <p:txBody>
          <a:bodyPr lIns="0" tIns="0" rIns="0" bIns="0"/>
          <a:lstStyle/>
          <a:p>
            <a:pPr>
              <a:buSzPct val="45000"/>
              <a:buFont typeface="StarSymbol"/>
              <a:buChar char=""/>
            </a:pPr>
            <a:r>
              <a:rPr lang="en-US" sz="2609">
                <a:latin typeface="Arial"/>
              </a:rPr>
              <a:t>Click to edit the outline text format</a:t>
            </a:r>
            <a:endParaRPr/>
          </a:p>
          <a:p>
            <a:pPr lvl="1">
              <a:buSzPct val="75000"/>
              <a:buFont typeface="StarSymbol"/>
              <a:buChar char=""/>
            </a:pPr>
            <a:r>
              <a:rPr lang="en-US" sz="2283">
                <a:latin typeface="Arial"/>
              </a:rPr>
              <a:t>Second Outline Level</a:t>
            </a:r>
            <a:endParaRPr/>
          </a:p>
          <a:p>
            <a:pPr lvl="2">
              <a:buSzPct val="45000"/>
              <a:buFont typeface="StarSymbol"/>
              <a:buChar char=""/>
            </a:pPr>
            <a:r>
              <a:rPr lang="en-US" sz="1956">
                <a:latin typeface="Arial"/>
              </a:rPr>
              <a:t>Third Outline Level</a:t>
            </a:r>
            <a:endParaRPr/>
          </a:p>
          <a:p>
            <a:pPr lvl="3">
              <a:buSzPct val="75000"/>
              <a:buFont typeface="StarSymbol"/>
              <a:buChar char=""/>
            </a:pPr>
            <a:r>
              <a:rPr lang="en-US" sz="1630">
                <a:latin typeface="Arial"/>
              </a:rPr>
              <a:t>Fourth Outline Level</a:t>
            </a:r>
            <a:endParaRPr/>
          </a:p>
          <a:p>
            <a:pPr lvl="4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Fifth Outline Level</a:t>
            </a:r>
            <a:endParaRPr/>
          </a:p>
          <a:p>
            <a:pPr lvl="5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ixth Outline Level</a:t>
            </a:r>
            <a:endParaRPr/>
          </a:p>
          <a:p>
            <a:pPr lvl="6">
              <a:buSzPct val="45000"/>
              <a:buFont typeface="StarSymbol"/>
              <a:buChar char=""/>
            </a:pPr>
            <a:r>
              <a:rPr lang="en-US" sz="1630">
                <a:latin typeface="Arial"/>
              </a:rPr>
              <a:t>Seventh Outline Level</a:t>
            </a:r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hf hdr="0" dt="0"/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Tabelle 14">
            <a:extLst>
              <a:ext uri="{FF2B5EF4-FFF2-40B4-BE49-F238E27FC236}">
                <a16:creationId xmlns:a16="http://schemas.microsoft.com/office/drawing/2014/main" id="{3ACA21A8-88F3-48BE-9714-F1F1A416E4A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5474804"/>
              </p:ext>
            </p:extLst>
          </p:nvPr>
        </p:nvGraphicFramePr>
        <p:xfrm>
          <a:off x="284384" y="510402"/>
          <a:ext cx="6107651" cy="742315"/>
        </p:xfrm>
        <a:graphic>
          <a:graphicData uri="http://schemas.openxmlformats.org/drawingml/2006/table">
            <a:tbl>
              <a:tblPr firstRow="1" firstCol="1" bandRow="1"/>
              <a:tblGrid>
                <a:gridCol w="57730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5211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7720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87024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3078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Nr</a:t>
                      </a:r>
                      <a:r>
                        <a:rPr lang="en-US" sz="9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.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Name 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Sequence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  <a:latin typeface="Calibri"/>
                          <a:ea typeface="Calibri"/>
                          <a:cs typeface="Times New Roman"/>
                        </a:rPr>
                        <a:t>Target strain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Target gene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5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kank1_atcc_for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cgtcccgggcaccggttgca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. fumigatus </a:t>
                      </a:r>
                      <a:r>
                        <a:rPr lang="en-GB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ΔfgnA</a:t>
                      </a: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, </a:t>
                      </a:r>
                      <a:r>
                        <a:rPr lang="en-GB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tet</a:t>
                      </a:r>
                      <a:r>
                        <a:rPr lang="en-GB" sz="900" i="1" baseline="300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On</a:t>
                      </a:r>
                      <a:r>
                        <a:rPr lang="en-GB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-fgnA</a:t>
                      </a: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 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5’ flank </a:t>
                      </a:r>
                      <a:r>
                        <a:rPr lang="en-US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gnA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6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Times New Roman"/>
                        </a:rPr>
                        <a:t>Flank1_atcc_rev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>
                          <a:effectLst/>
                          <a:latin typeface="Calibri"/>
                          <a:ea typeface="Calibri"/>
                          <a:cs typeface="Times New Roman"/>
                        </a:rPr>
                        <a:t>ggtatctttgagacagata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. fumigatus </a:t>
                      </a:r>
                      <a:r>
                        <a:rPr lang="en-GB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ΔfgnA</a:t>
                      </a: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, </a:t>
                      </a:r>
                      <a:r>
                        <a:rPr lang="en-GB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tet</a:t>
                      </a:r>
                      <a:r>
                        <a:rPr lang="en-GB" sz="900" i="1" baseline="300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On</a:t>
                      </a:r>
                      <a:r>
                        <a:rPr lang="en-GB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-fgnA</a:t>
                      </a: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5’ flank fgnA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900" b="0" i="0" u="none" strike="noStrike" kern="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/>
                          <a:ea typeface="Calibri"/>
                          <a:cs typeface="Times New Roman"/>
                        </a:rPr>
                        <a:t>P47</a:t>
                      </a:r>
                      <a:endParaRPr kumimoji="0" lang="de-DE" sz="1100" b="0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3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F5000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20">
                          <a:solidFill>
                            <a:srgbClr val="000000"/>
                          </a:solidFill>
                          <a:effectLst/>
                          <a:latin typeface="Calibri"/>
                          <a:ea typeface="Calibri"/>
                          <a:cs typeface="Courier New"/>
                        </a:rPr>
                        <a:t>CCGGTGAAGCTGACACGTTGG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. nidulans </a:t>
                      </a:r>
                      <a:r>
                        <a:rPr lang="en-US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gpdA</a:t>
                      </a:r>
                      <a:r>
                        <a:rPr lang="en-US" sz="9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r>
                        <a:rPr lang="en-US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gnA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gnA</a:t>
                      </a:r>
                      <a:endParaRPr lang="de-DE" sz="110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P48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spc="-3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fu1g01010R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cap="all" spc="-20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CTGCTGGATCTTCTCGGC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A. </a:t>
                      </a:r>
                      <a:r>
                        <a:rPr lang="en-GB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nidulans</a:t>
                      </a:r>
                      <a:r>
                        <a:rPr lang="en-GB" sz="900" i="1" dirty="0">
                          <a:effectLst/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gpdA</a:t>
                      </a:r>
                      <a:r>
                        <a:rPr lang="en-US" sz="900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-</a:t>
                      </a:r>
                      <a:r>
                        <a:rPr lang="en-US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gnA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900" i="1" dirty="0" err="1">
                          <a:effectLst/>
                          <a:latin typeface="Calibri"/>
                          <a:ea typeface="Calibri"/>
                          <a:cs typeface="Times New Roman"/>
                        </a:rPr>
                        <a:t>fgnA</a:t>
                      </a:r>
                      <a:endParaRPr lang="de-DE" sz="1100" dirty="0">
                        <a:effectLst/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68580" marR="6858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8" name="Textfeld 24">
            <a:extLst>
              <a:ext uri="{FF2B5EF4-FFF2-40B4-BE49-F238E27FC236}">
                <a16:creationId xmlns:a16="http://schemas.microsoft.com/office/drawing/2014/main" id="{87B7A165-B6A7-45EC-8874-43E938111F25}"/>
              </a:ext>
            </a:extLst>
          </p:cNvPr>
          <p:cNvSpPr txBox="1"/>
          <p:nvPr/>
        </p:nvSpPr>
        <p:spPr>
          <a:xfrm>
            <a:off x="2544541" y="37728"/>
            <a:ext cx="18165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le 4</a:t>
            </a:r>
          </a:p>
        </p:txBody>
      </p:sp>
    </p:spTree>
    <p:extLst>
      <p:ext uri="{BB962C8B-B14F-4D97-AF65-F5344CB8AC3E}">
        <p14:creationId xmlns:p14="http://schemas.microsoft.com/office/powerpoint/2010/main" val="558902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6</TotalTime>
  <Words>61</Words>
  <Application>Microsoft Office PowerPoint</Application>
  <PresentationFormat>Custom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tarSymbo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ia Stroe</dc:creator>
  <cp:lastModifiedBy>Maria</cp:lastModifiedBy>
  <cp:revision>1463</cp:revision>
  <cp:lastPrinted>2019-03-07T13:16:11Z</cp:lastPrinted>
  <dcterms:modified xsi:type="dcterms:W3CDTF">2020-02-05T16:15:36Z</dcterms:modified>
</cp:coreProperties>
</file>